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0E57D-53E6-49D3-B827-B5F5510C52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7C11F-6FB7-4C25-9789-76BDA937AD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567A5-514B-42A4-94CA-959B5CB0FE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2B4D6-84C6-453C-93A6-838B92B603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59E86-E94F-4E29-9BC1-93F5383BDF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B41ED-9543-4F57-8FFC-A59BBCB6F0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7872B-F103-4222-959E-69B74771F3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D6DE6-0E33-454B-AE49-58B9F8051D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A0405-E26E-4878-B176-0CBBBC2527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62B61-6742-4D86-A7E3-F8B724A2D9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25744-DCD6-4F78-982D-1D3A033F9E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9DC84-7CC9-4414-B227-9915FCF12B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D9C095-E85B-4F9F-A9A2-8A3B3635C08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9-14" descr=""/>
          <p:cNvPicPr/>
          <p:nvPr/>
        </p:nvPicPr>
        <p:blipFill>
          <a:blip r:embed="rId1"/>
          <a:srcRect l="4993" t="0" r="7430" b="0"/>
          <a:stretch/>
        </p:blipFill>
        <p:spPr>
          <a:xfrm>
            <a:off x="762120" y="685800"/>
            <a:ext cx="7619760" cy="50292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85800" y="5943600"/>
            <a:ext cx="81532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. S-3: No d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ection of 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GFR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15 bp deletion in human lung by MAP in 4 normal lung samples and mushroom contro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94200" y="227160"/>
            <a:ext cx="218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nalytical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ensi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114800" y="228600"/>
            <a:ext cx="19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Negative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5407800">
            <a:off x="2255040" y="-275400"/>
            <a:ext cx="236520" cy="1828800"/>
          </a:xfrm>
          <a:custGeom>
            <a:avLst/>
            <a:gdLst>
              <a:gd name="textAreaLeft" fmla="*/ 151200 w 236520"/>
              <a:gd name="textAreaRight" fmla="*/ 236880 w 236520"/>
              <a:gd name="textAreaTop" fmla="*/ 54360 h 1828800"/>
              <a:gd name="textAreaBottom" fmla="*/ 1774440 h 1828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32"/>
                  <a:pt x="10800" y="2063"/>
                </a:cubicBezTo>
                <a:lnTo>
                  <a:pt x="10800" y="8737"/>
                </a:lnTo>
                <a:cubicBezTo>
                  <a:pt x="10800" y="9769"/>
                  <a:pt x="5400" y="10800"/>
                  <a:pt x="0" y="10800"/>
                </a:cubicBezTo>
                <a:cubicBezTo>
                  <a:pt x="5400" y="10800"/>
                  <a:pt x="10800" y="11832"/>
                  <a:pt x="10800" y="12863"/>
                </a:cubicBezTo>
                <a:lnTo>
                  <a:pt x="10800" y="19537"/>
                </a:lnTo>
                <a:cubicBezTo>
                  <a:pt x="10800" y="20569"/>
                  <a:pt x="16200" y="21600"/>
                  <a:pt x="21600" y="21600"/>
                </a:cubicBezTo>
              </a:path>
            </a:pathLst>
          </a:custGeom>
          <a:noFill/>
          <a:ln w="316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 anchorCtr="1" vert="eaVert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5407800">
            <a:off x="4877280" y="-730800"/>
            <a:ext cx="236520" cy="2743200"/>
          </a:xfrm>
          <a:custGeom>
            <a:avLst/>
            <a:gdLst>
              <a:gd name="textAreaLeft" fmla="*/ 151200 w 236520"/>
              <a:gd name="textAreaRight" fmla="*/ 236880 w 236520"/>
              <a:gd name="textAreaTop" fmla="*/ 81720 h 2743200"/>
              <a:gd name="textAreaBottom" fmla="*/ 2661480 h 27432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32"/>
                  <a:pt x="10800" y="2063"/>
                </a:cubicBezTo>
                <a:lnTo>
                  <a:pt x="10800" y="8737"/>
                </a:lnTo>
                <a:cubicBezTo>
                  <a:pt x="10800" y="9769"/>
                  <a:pt x="5400" y="10800"/>
                  <a:pt x="0" y="10800"/>
                </a:cubicBezTo>
                <a:cubicBezTo>
                  <a:pt x="5400" y="10800"/>
                  <a:pt x="10800" y="11832"/>
                  <a:pt x="10800" y="12863"/>
                </a:cubicBezTo>
                <a:lnTo>
                  <a:pt x="10800" y="19537"/>
                </a:lnTo>
                <a:cubicBezTo>
                  <a:pt x="10800" y="20569"/>
                  <a:pt x="16200" y="21600"/>
                  <a:pt x="21600" y="21600"/>
                </a:cubicBezTo>
              </a:path>
            </a:pathLst>
          </a:custGeom>
          <a:noFill/>
          <a:ln w="316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 anchorCtr="1" vert="eaVert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85800" y="685800"/>
            <a:ext cx="70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0  10    4     2     1    ½    ¼   0     0     0    0     0     0     0    0     0     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04880" y="1447920"/>
            <a:ext cx="744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66"/>
                </a:solidFill>
                <a:latin typeface="Tahoma"/>
              </a:rPr>
              <a:t>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+   4+   A     B    C     D    E     F     G    H    I     J     K     L    M    N     O     P    Q    R     S    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85800" y="2286000"/>
            <a:ext cx="754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66"/>
                </a:solidFill>
                <a:latin typeface="Tahoma"/>
              </a:rPr>
              <a:t> 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+   4+   A     B    C     D    E     F     G    H    I     J     K     L    M    N     O     P    Q   R     S    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95160" y="3733920"/>
            <a:ext cx="761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66"/>
                </a:solidFill>
                <a:latin typeface="Tahoma"/>
              </a:rPr>
              <a:t> 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 10+  4+   A     B    C     D    E     F     G    H    I     J     K     L    M    N     O     P    Q   R     S    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942840" y="2971800"/>
            <a:ext cx="7391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66"/>
                </a:solidFill>
                <a:latin typeface="Tahoma"/>
              </a:rPr>
              <a:t>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+   4+   A     B    C     D    E     F     G    H    I     J     K     L    M    N     O     P    Q   R     S    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047600" y="4495680"/>
            <a:ext cx="777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+   4+   A     B    C     D    E     F     G    H    I     J     K     L    M    N     O     P    Q   R     S    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04880" y="18288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66"/>
                </a:solidFill>
                <a:latin typeface="Arial"/>
              </a:rPr>
              <a:t>ID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85800" y="257508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66"/>
                </a:solidFill>
                <a:latin typeface="Arial"/>
              </a:rPr>
              <a:t>ID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23960" y="335268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66"/>
                </a:solidFill>
                <a:latin typeface="Arial"/>
              </a:rPr>
              <a:t>ID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33320" y="41148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66"/>
                </a:solidFill>
                <a:latin typeface="Arial"/>
              </a:rPr>
              <a:t>ID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33320" y="4876920"/>
            <a:ext cx="99072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66"/>
                </a:solidFill>
                <a:latin typeface="Arial"/>
              </a:rPr>
              <a:t>Mushroo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971640" y="87948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00"/>
                </a:solidFill>
                <a:latin typeface="Arial"/>
              </a:rPr>
              <a:t>Copy numb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7T22:18:58Z</dcterms:created>
  <dc:creator>cbuzin</dc:creator>
  <dc:description/>
  <dc:language>en-US</dc:language>
  <cp:lastModifiedBy>zhchen</cp:lastModifiedBy>
  <dcterms:modified xsi:type="dcterms:W3CDTF">2009-07-31T21:49:35Z</dcterms:modified>
  <cp:revision>3</cp:revision>
  <dc:subject/>
  <dc:title>Slide 1</dc:title>
</cp:coreProperties>
</file>